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754448-F0DE-40F4-BDA5-0274FDC19D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B2BFB-4FE4-4136-95B2-00A443A7D3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305C1-61C7-46F5-8C51-F49B2AB550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C2896-E61A-46BD-9C6F-0DF62B7201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E5352-334F-42E7-A358-83CFDFA00F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43FA0C-A789-414F-80A3-7B61620B43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F4F17F-C49B-483A-8D22-E1CDDAC3A6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AC7C50-A5B7-4AE0-AAEF-FF8EEC1330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EB2C77-CE12-4A06-93DA-7DCD7B8B9B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1ACF69-1442-4A98-8660-02327325D0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D1DBB-3210-4ED9-BCE7-BA18CE197D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A2D594-213E-42B7-9E1F-1ABB3783F1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665CE5-6C1B-414B-97DE-6DB1C547A77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Freeform 4"/>
          <p:cNvSpPr/>
          <p:nvPr/>
        </p:nvSpPr>
        <p:spPr>
          <a:xfrm>
            <a:off x="825480" y="2670120"/>
            <a:ext cx="1633680" cy="917640"/>
          </a:xfrm>
          <a:custGeom>
            <a:avLst/>
            <a:gdLst>
              <a:gd name="textAreaLeft" fmla="*/ 0 w 1633680"/>
              <a:gd name="textAreaRight" fmla="*/ 1634040 w 1633680"/>
              <a:gd name="textAreaTop" fmla="*/ 0 h 917640"/>
              <a:gd name="textAreaBottom" fmla="*/ 918000 h 917640"/>
            </a:gdLst>
            <a:ahLst/>
            <a:rect l="textAreaLeft" t="textAreaTop" r="textAreaRight" b="textAreaBottom"/>
            <a:pathLst>
              <a:path w="1497" h="997">
                <a:moveTo>
                  <a:pt x="0" y="997"/>
                </a:moveTo>
                <a:lnTo>
                  <a:pt x="862" y="997"/>
                </a:lnTo>
                <a:lnTo>
                  <a:pt x="1497" y="0"/>
                </a:lnTo>
              </a:path>
            </a:pathLst>
          </a:custGeom>
          <a:noFill/>
          <a:ln w="38160">
            <a:solidFill>
              <a:srgbClr val="d9d9d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Freeform 5"/>
          <p:cNvSpPr/>
          <p:nvPr/>
        </p:nvSpPr>
        <p:spPr>
          <a:xfrm flipV="1">
            <a:off x="825480" y="3674520"/>
            <a:ext cx="1633680" cy="950760"/>
          </a:xfrm>
          <a:custGeom>
            <a:avLst/>
            <a:gdLst>
              <a:gd name="textAreaLeft" fmla="*/ 0 w 1633680"/>
              <a:gd name="textAreaRight" fmla="*/ 1634040 w 1633680"/>
              <a:gd name="textAreaTop" fmla="*/ -360 h 950760"/>
              <a:gd name="textAreaBottom" fmla="*/ 950760 h 950760"/>
            </a:gdLst>
            <a:ahLst/>
            <a:rect l="textAreaLeft" t="textAreaTop" r="textAreaRight" b="textAreaBottom"/>
            <a:pathLst>
              <a:path w="1497" h="997">
                <a:moveTo>
                  <a:pt x="0" y="997"/>
                </a:moveTo>
                <a:lnTo>
                  <a:pt x="862" y="997"/>
                </a:lnTo>
                <a:lnTo>
                  <a:pt x="1497" y="0"/>
                </a:lnTo>
              </a:path>
            </a:pathLst>
          </a:custGeom>
          <a:noFill/>
          <a:ln w="38160">
            <a:solidFill>
              <a:srgbClr val="d9d9d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rot="10800000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6"/>
          <p:cNvSpPr/>
          <p:nvPr/>
        </p:nvSpPr>
        <p:spPr>
          <a:xfrm flipV="1">
            <a:off x="1870200" y="2734920"/>
            <a:ext cx="660240" cy="879480"/>
          </a:xfrm>
          <a:prstGeom prst="line">
            <a:avLst/>
          </a:prstGeom>
          <a:ln w="381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645840" y="3403440"/>
            <a:ext cx="27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2499840" y="2563920"/>
            <a:ext cx="27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4"/>
          <p:cNvSpPr/>
          <p:nvPr/>
        </p:nvSpPr>
        <p:spPr>
          <a:xfrm>
            <a:off x="2322360" y="2444760"/>
            <a:ext cx="27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7"/>
          <p:cNvSpPr/>
          <p:nvPr/>
        </p:nvSpPr>
        <p:spPr>
          <a:xfrm>
            <a:off x="2512080" y="4473720"/>
            <a:ext cx="27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9"/>
          <p:cNvSpPr/>
          <p:nvPr/>
        </p:nvSpPr>
        <p:spPr>
          <a:xfrm>
            <a:off x="635040" y="3633840"/>
            <a:ext cx="3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7"/>
          <p:cNvSpPr/>
          <p:nvPr/>
        </p:nvSpPr>
        <p:spPr>
          <a:xfrm>
            <a:off x="2314080" y="4605480"/>
            <a:ext cx="27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43"/>
          <p:cNvSpPr/>
          <p:nvPr/>
        </p:nvSpPr>
        <p:spPr>
          <a:xfrm>
            <a:off x="1982160" y="3809880"/>
            <a:ext cx="168120" cy="2430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19"/>
          <p:cNvSpPr/>
          <p:nvPr/>
        </p:nvSpPr>
        <p:spPr>
          <a:xfrm>
            <a:off x="1952640" y="3767040"/>
            <a:ext cx="30240" cy="44640"/>
          </a:xfrm>
          <a:prstGeom prst="line">
            <a:avLst/>
          </a:prstGeom>
          <a:ln w="381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23"/>
          <p:cNvSpPr/>
          <p:nvPr/>
        </p:nvSpPr>
        <p:spPr>
          <a:xfrm flipV="1">
            <a:off x="2017800" y="3543480"/>
            <a:ext cx="360360" cy="217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24"/>
          <p:cNvSpPr/>
          <p:nvPr/>
        </p:nvSpPr>
        <p:spPr>
          <a:xfrm>
            <a:off x="2345040" y="3390840"/>
            <a:ext cx="84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RNA prim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43"/>
          <p:cNvSpPr/>
          <p:nvPr/>
        </p:nvSpPr>
        <p:spPr>
          <a:xfrm>
            <a:off x="2201760" y="4118040"/>
            <a:ext cx="206640" cy="28728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43"/>
          <p:cNvSpPr/>
          <p:nvPr/>
        </p:nvSpPr>
        <p:spPr>
          <a:xfrm>
            <a:off x="2403360" y="4398840"/>
            <a:ext cx="122400" cy="171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53"/>
          <p:cNvSpPr/>
          <p:nvPr/>
        </p:nvSpPr>
        <p:spPr>
          <a:xfrm flipV="1">
            <a:off x="2125800" y="3749400"/>
            <a:ext cx="431640" cy="145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5"/>
          <p:cNvSpPr/>
          <p:nvPr/>
        </p:nvSpPr>
        <p:spPr>
          <a:xfrm>
            <a:off x="2513160" y="3610080"/>
            <a:ext cx="86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DNA por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96"/>
          <p:cNvSpPr/>
          <p:nvPr/>
        </p:nvSpPr>
        <p:spPr>
          <a:xfrm>
            <a:off x="2613960" y="3876840"/>
            <a:ext cx="1820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Okazaki fragment process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97"/>
          <p:cNvSpPr/>
          <p:nvPr/>
        </p:nvSpPr>
        <p:spPr>
          <a:xfrm flipV="1">
            <a:off x="2465280" y="4308480"/>
            <a:ext cx="10008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98"/>
          <p:cNvSpPr/>
          <p:nvPr/>
        </p:nvSpPr>
        <p:spPr>
          <a:xfrm>
            <a:off x="2484720" y="4119480"/>
            <a:ext cx="201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Ligation to the adjacent frag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ight Brace 99"/>
          <p:cNvSpPr/>
          <p:nvPr/>
        </p:nvSpPr>
        <p:spPr>
          <a:xfrm>
            <a:off x="3324240" y="3394080"/>
            <a:ext cx="71280" cy="431640"/>
          </a:xfrm>
          <a:custGeom>
            <a:avLst/>
            <a:gdLst>
              <a:gd name="textAreaLeft" fmla="*/ 0 w 71280"/>
              <a:gd name="textAreaRight" fmla="*/ 25560 w 71280"/>
              <a:gd name="textAreaTop" fmla="*/ 1800 h 431640"/>
              <a:gd name="textAreaBottom" fmla="*/ 429840 h 431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49"/>
                  <a:pt x="10800" y="298"/>
                </a:cubicBezTo>
                <a:lnTo>
                  <a:pt x="10800" y="10502"/>
                </a:lnTo>
                <a:cubicBezTo>
                  <a:pt x="10800" y="10651"/>
                  <a:pt x="16200" y="10800"/>
                  <a:pt x="21600" y="10800"/>
                </a:cubicBezTo>
                <a:cubicBezTo>
                  <a:pt x="16200" y="10800"/>
                  <a:pt x="10800" y="10949"/>
                  <a:pt x="10800" y="11098"/>
                </a:cubicBezTo>
                <a:lnTo>
                  <a:pt x="10800" y="21302"/>
                </a:lnTo>
                <a:cubicBezTo>
                  <a:pt x="10800" y="21451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00"/>
          <p:cNvSpPr/>
          <p:nvPr/>
        </p:nvSpPr>
        <p:spPr>
          <a:xfrm>
            <a:off x="3333960" y="3400560"/>
            <a:ext cx="1207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Okazaki fragme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ynthe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101"/>
          <p:cNvSpPr/>
          <p:nvPr/>
        </p:nvSpPr>
        <p:spPr>
          <a:xfrm>
            <a:off x="2122560" y="4037040"/>
            <a:ext cx="142920" cy="1429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traight Connector 102"/>
          <p:cNvSpPr/>
          <p:nvPr/>
        </p:nvSpPr>
        <p:spPr>
          <a:xfrm flipV="1">
            <a:off x="2244600" y="4000680"/>
            <a:ext cx="360360" cy="93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ight Brace 108"/>
          <p:cNvSpPr/>
          <p:nvPr/>
        </p:nvSpPr>
        <p:spPr>
          <a:xfrm>
            <a:off x="5589720" y="3409920"/>
            <a:ext cx="120600" cy="1009800"/>
          </a:xfrm>
          <a:custGeom>
            <a:avLst/>
            <a:gdLst>
              <a:gd name="textAreaLeft" fmla="*/ 0 w 120600"/>
              <a:gd name="textAreaRight" fmla="*/ 43560 w 120600"/>
              <a:gd name="textAreaTop" fmla="*/ 2880 h 1009800"/>
              <a:gd name="textAreaBottom" fmla="*/ 1006920 h 1009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08"/>
                  <a:pt x="10800" y="215"/>
                </a:cubicBezTo>
                <a:lnTo>
                  <a:pt x="10800" y="10585"/>
                </a:lnTo>
                <a:cubicBezTo>
                  <a:pt x="10800" y="10693"/>
                  <a:pt x="16200" y="10800"/>
                  <a:pt x="21600" y="10800"/>
                </a:cubicBezTo>
                <a:cubicBezTo>
                  <a:pt x="16200" y="10800"/>
                  <a:pt x="10800" y="10908"/>
                  <a:pt x="10800" y="11015"/>
                </a:cubicBezTo>
                <a:lnTo>
                  <a:pt x="10800" y="21385"/>
                </a:lnTo>
                <a:cubicBezTo>
                  <a:pt x="10800" y="21493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09"/>
          <p:cNvSpPr/>
          <p:nvPr/>
        </p:nvSpPr>
        <p:spPr>
          <a:xfrm>
            <a:off x="3290040" y="2652840"/>
            <a:ext cx="101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Leading stran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10"/>
          <p:cNvSpPr/>
          <p:nvPr/>
        </p:nvSpPr>
        <p:spPr>
          <a:xfrm>
            <a:off x="5657040" y="3711600"/>
            <a:ext cx="10508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Lagging stran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ynthe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12"/>
          <p:cNvSpPr/>
          <p:nvPr/>
        </p:nvSpPr>
        <p:spPr>
          <a:xfrm>
            <a:off x="698040" y="4021200"/>
            <a:ext cx="110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arental stran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113"/>
          <p:cNvSpPr/>
          <p:nvPr/>
        </p:nvSpPr>
        <p:spPr>
          <a:xfrm flipV="1">
            <a:off x="1124640" y="3681360"/>
            <a:ext cx="96840" cy="33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115"/>
          <p:cNvSpPr/>
          <p:nvPr/>
        </p:nvSpPr>
        <p:spPr>
          <a:xfrm flipH="1" flipV="1">
            <a:off x="972720" y="3587760"/>
            <a:ext cx="152280" cy="441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121"/>
          <p:cNvSpPr/>
          <p:nvPr/>
        </p:nvSpPr>
        <p:spPr>
          <a:xfrm>
            <a:off x="2389320" y="2644920"/>
            <a:ext cx="176040" cy="14112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122"/>
          <p:cNvSpPr/>
          <p:nvPr/>
        </p:nvSpPr>
        <p:spPr>
          <a:xfrm>
            <a:off x="2373480" y="2660760"/>
            <a:ext cx="174600" cy="14292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123"/>
          <p:cNvSpPr/>
          <p:nvPr/>
        </p:nvSpPr>
        <p:spPr>
          <a:xfrm flipH="1">
            <a:off x="2391840" y="4512600"/>
            <a:ext cx="173160" cy="12708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124"/>
          <p:cNvSpPr/>
          <p:nvPr/>
        </p:nvSpPr>
        <p:spPr>
          <a:xfrm flipH="1">
            <a:off x="2363400" y="4480920"/>
            <a:ext cx="189000" cy="14292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129"/>
          <p:cNvSpPr/>
          <p:nvPr/>
        </p:nvSpPr>
        <p:spPr>
          <a:xfrm>
            <a:off x="878040" y="3537000"/>
            <a:ext cx="1440" cy="18108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130"/>
          <p:cNvSpPr/>
          <p:nvPr/>
        </p:nvSpPr>
        <p:spPr>
          <a:xfrm>
            <a:off x="849240" y="3530520"/>
            <a:ext cx="0" cy="18900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ight Arrow 136"/>
          <p:cNvSpPr/>
          <p:nvPr/>
        </p:nvSpPr>
        <p:spPr>
          <a:xfrm rot="10800000">
            <a:off x="1484280" y="3371760"/>
            <a:ext cx="216000" cy="14472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137"/>
          <p:cNvSpPr/>
          <p:nvPr/>
        </p:nvSpPr>
        <p:spPr>
          <a:xfrm>
            <a:off x="448560" y="2755800"/>
            <a:ext cx="1674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Direction of the replic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fork move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traight Connector 138"/>
          <p:cNvSpPr/>
          <p:nvPr/>
        </p:nvSpPr>
        <p:spPr>
          <a:xfrm flipH="1" flipV="1">
            <a:off x="1197000" y="3155760"/>
            <a:ext cx="287280" cy="215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ight Brace 81"/>
          <p:cNvSpPr/>
          <p:nvPr/>
        </p:nvSpPr>
        <p:spPr>
          <a:xfrm>
            <a:off x="4459320" y="3914640"/>
            <a:ext cx="71280" cy="432000"/>
          </a:xfrm>
          <a:custGeom>
            <a:avLst/>
            <a:gdLst>
              <a:gd name="textAreaLeft" fmla="*/ 0 w 71280"/>
              <a:gd name="textAreaRight" fmla="*/ 25560 w 71280"/>
              <a:gd name="textAreaTop" fmla="*/ 1800 h 432000"/>
              <a:gd name="textAreaBottom" fmla="*/ 430200 h 432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49"/>
                  <a:pt x="10800" y="298"/>
                </a:cubicBezTo>
                <a:lnTo>
                  <a:pt x="10800" y="10502"/>
                </a:lnTo>
                <a:cubicBezTo>
                  <a:pt x="10800" y="10651"/>
                  <a:pt x="16200" y="10800"/>
                  <a:pt x="21600" y="10800"/>
                </a:cubicBezTo>
                <a:cubicBezTo>
                  <a:pt x="16200" y="10800"/>
                  <a:pt x="10800" y="10949"/>
                  <a:pt x="10800" y="11098"/>
                </a:cubicBezTo>
                <a:lnTo>
                  <a:pt x="10800" y="21302"/>
                </a:lnTo>
                <a:cubicBezTo>
                  <a:pt x="10800" y="21451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100"/>
          <p:cNvSpPr/>
          <p:nvPr/>
        </p:nvSpPr>
        <p:spPr>
          <a:xfrm>
            <a:off x="4488120" y="3925800"/>
            <a:ext cx="1207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Okazaki fragme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atu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87"/>
          <p:cNvSpPr/>
          <p:nvPr/>
        </p:nvSpPr>
        <p:spPr>
          <a:xfrm flipV="1">
            <a:off x="2205000" y="2790720"/>
            <a:ext cx="1131840" cy="439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119"/>
          <p:cNvSpPr/>
          <p:nvPr/>
        </p:nvSpPr>
        <p:spPr>
          <a:xfrm flipH="1">
            <a:off x="2111040" y="3921840"/>
            <a:ext cx="173160" cy="12708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120"/>
          <p:cNvSpPr/>
          <p:nvPr/>
        </p:nvSpPr>
        <p:spPr>
          <a:xfrm flipH="1">
            <a:off x="2082960" y="3890160"/>
            <a:ext cx="188640" cy="14292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Oval 125"/>
          <p:cNvSpPr/>
          <p:nvPr/>
        </p:nvSpPr>
        <p:spPr>
          <a:xfrm>
            <a:off x="2328840" y="4319640"/>
            <a:ext cx="142920" cy="1429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3"/>
          <p:cNvSpPr/>
          <p:nvPr/>
        </p:nvSpPr>
        <p:spPr>
          <a:xfrm>
            <a:off x="3645000" y="5859360"/>
            <a:ext cx="297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uhanen et al., Supplementary Figure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6T17:15:02Z</dcterms:created>
  <dc:creator>rmgzyta</dc:creator>
  <dc:description/>
  <dc:language>en-US</dc:language>
  <cp:lastModifiedBy>rmgzyta</cp:lastModifiedBy>
  <dcterms:modified xsi:type="dcterms:W3CDTF">2011-06-26T15:07:39Z</dcterms:modified>
  <cp:revision>75</cp:revision>
  <dc:subject/>
  <dc:title>Slide 1</dc:title>
</cp:coreProperties>
</file>